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3"/>
  </p:normalViewPr>
  <p:slideViewPr>
    <p:cSldViewPr snapToGrid="0" snapToObjects="1">
      <p:cViewPr>
        <p:scale>
          <a:sx n="109" d="100"/>
          <a:sy n="109" d="100"/>
        </p:scale>
        <p:origin x="680" y="4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D282FC-5AAD-EE48-902F-5B3FC8D9A0F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21AA762-1477-F14E-B57D-8750C249BA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ADDAA6-2A2D-0343-ADDA-2F277CEA3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5BE766-C439-E646-B368-EB1EA7B7A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9616CB-717F-B44C-AD22-9B9860AA9F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0762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79517E0-8F71-0847-83D4-74948EC6E1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F963BB5-0208-D64A-BB24-122953A4DD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4FE1E8-C417-194E-98EF-06F63E0FD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73ABC4-0BD4-4547-A8DB-2D3F279CA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D9BD15D-3B08-1B46-A03C-4F1C6A837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14359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FE82287-EB94-DF48-99EE-D09D6C26A6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D20560D-1BD2-FF4A-9998-A99FE230FD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0BC054D-6342-6546-9F19-1F089A4362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4C3F5F-7006-FA4C-9F39-11C82E966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CC2BA5-7BE5-334D-951B-BD67562BDE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699427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4E1A35-BA08-7847-8AAD-89CF1A63B4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9E9BA43-30A2-3449-95C8-E71D6BFCC8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7B4451-EF45-AB40-9792-EBF34DFF6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89C1AC-AA35-804C-8FE6-1D7867FC97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8EAF3EF-C929-EC46-8524-5A89F090FC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84598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266B65-7A22-BF47-96FC-6C139098BB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EDA6976-EDEA-1143-A320-02998529AA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F97E8A-551B-DF4E-8799-862C02ECD4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884AC6-AF16-244D-987E-2683676DA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BD344C-6E07-E049-BD10-2E8946DCBE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656756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4290FC-3C97-784D-A6FB-37D069EF63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6545AA9-E2F6-7B4B-9C69-969ECC631D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766E57A-227D-364E-A709-C5F14D24A38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32A6ED-46C0-CA43-9B4A-89392E729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B7E462B-9CE9-4D46-8552-A24A3565B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36DF3F7-EF9C-ED46-8E5D-2719B6D58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90944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6386B5-4ED0-AB47-B63C-44D8FE788E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BB26ECD-C697-E645-A28B-5E39E8E151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9358D62-F54F-F347-97ED-D0B271D926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9EDCA40-EDBA-4641-A8D8-6B71A51B92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5DD74E6-5DEA-D24E-BD5A-B71B18487F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A1C716B-73BF-1942-98FF-751D1C6A1D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E41DB75-E2A2-9E46-A603-D5844BF3A4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527E182-AE8C-8B44-A120-4F1D9C0348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9144291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E778D23-6FAD-734B-AE1C-767FDD5A1F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70CDC6F-E78A-104E-B044-6FBB605FB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1C2C669-36B3-104C-BDB3-1402F2A61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88579DB-C17E-2E45-87B4-06DBCEEDF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502912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C8057C5-BFFD-FA40-948E-6B7ADD2F3C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44F2005E-C5D5-1146-ACB2-D44BEDB0E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38979F1-4456-8542-8F52-48D27AA53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19824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A0FE51-584E-724F-8D87-A491E5453D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8992000-5077-8C4D-887B-1FC7D797000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FE9FA59-8400-BF48-826A-FDA1FFF3DC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CC850A-5C3C-6142-BFDC-293A25F65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09F93F0-AE6C-4E4F-AA38-851A9F7CA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3B9694F-A520-4140-836D-2214EE8C0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45463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D8E132-998A-494B-AE60-B67191DE40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10D59E9-7D4A-2B4A-929E-8D232CC017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EB43222-2F10-6745-A6C0-F070B17BED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5B516BA-FBCB-D648-9863-2722A608D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55C2D56-7E71-A74C-9307-0CB4333982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1748638-A94D-6E44-872E-8455DBEBD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1955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640DE46-5FD7-7946-B64F-E58E6AFDE3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3BEDE6B-8B6D-4543-98DD-3B848C00A6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A39DC15-EFD8-0347-925B-D40CF986B1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77598-AE17-3B4C-8265-8437757752EA}" type="datetimeFigureOut">
              <a:rPr kumimoji="1" lang="zh-CN" altLang="en-US" smtClean="0"/>
              <a:t>2021/8/13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A36AE7-4C7B-ED4F-96E4-20A2D7CDB1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9A47F2C-0E41-D743-9FEE-84394AD3B1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D72D85-67AC-FF46-89B8-CD3CF883BA1A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6033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2BA1EE9-BF14-5540-943A-DC2047E18A35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815" y="78058"/>
            <a:ext cx="11441151" cy="6701883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200035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BE46649D-2BB1-7E47-918C-87FD8922C733}"/>
              </a:ext>
            </a:extLst>
          </p:cNvPr>
          <p:cNvSpPr txBox="1"/>
          <p:nvPr/>
        </p:nvSpPr>
        <p:spPr>
          <a:xfrm>
            <a:off x="1367566" y="1228398"/>
            <a:ext cx="10661524" cy="29625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20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itle of data:</a:t>
            </a:r>
            <a:endParaRPr lang="zh-CN" altLang="zh-CN" sz="2000" b="1" kern="1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esults of TRIB3 primer sequences blasting</a:t>
            </a:r>
            <a:endParaRPr lang="zh-CN" altLang="zh-CN" kern="1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endParaRPr lang="en-US" altLang="zh-CN" sz="2000" kern="1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altLang="zh-CN" sz="2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scription of data:</a:t>
            </a:r>
            <a:endParaRPr lang="zh-CN" altLang="zh-CN" sz="2000" b="1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" altLang="zh-CN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results show that the </a:t>
            </a:r>
            <a:r>
              <a:rPr lang="en-US" altLang="zh-CN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imer</a:t>
            </a:r>
            <a:r>
              <a:rPr lang="en" altLang="zh-CN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o</a:t>
            </a:r>
            <a:r>
              <a:rPr lang="en-US" altLang="zh-CN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zh-CN" altLang="en-US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IB3</a:t>
            </a:r>
            <a:r>
              <a:rPr lang="zh-CN" altLang="en-US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ave</a:t>
            </a:r>
            <a:r>
              <a:rPr lang="en" altLang="zh-CN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ood</a:t>
            </a:r>
            <a:r>
              <a:rPr lang="zh-CN" altLang="en-US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" altLang="zh-CN" dirty="0">
                <a:solidFill>
                  <a:srgbClr val="2A2A2A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pecificity</a:t>
            </a:r>
            <a:endParaRPr lang="zh-CN" altLang="en-US" dirty="0">
              <a:solidFill>
                <a:srgbClr val="2A2A2A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75148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6</Words>
  <Application>Microsoft Macintosh PowerPoint</Application>
  <PresentationFormat>宽屏</PresentationFormat>
  <Paragraphs>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903898502@qq.com</dc:creator>
  <cp:lastModifiedBy>903898502@qq.com</cp:lastModifiedBy>
  <cp:revision>4</cp:revision>
  <dcterms:created xsi:type="dcterms:W3CDTF">2021-08-13T07:57:27Z</dcterms:created>
  <dcterms:modified xsi:type="dcterms:W3CDTF">2021-08-13T08:15:21Z</dcterms:modified>
</cp:coreProperties>
</file>